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735E5B-3F19-4E1B-823D-679F95D78B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586C33-F7EC-4011-A970-113DA0F064B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AB0559-ED6E-48A2-9F6C-0E8822F00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900F4D-BA2C-400E-806A-4FC0EE9313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EBB68F-50E4-4EB8-8279-E7FF7A759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3084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4A3EC1-EBBD-41D0-8D43-016AB06A2E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2C7CD0-CCE9-422B-B1CF-72146E53B6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95FCDC-F703-47F5-AAF6-AEBAB3364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53D71B-7338-4EC1-9CE3-2D4A8181A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332B2E-2259-4912-95C2-D7814E34B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4349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781C66-756D-474F-A0B6-1122E67525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997531-7B9D-463E-BEA1-92F472673E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A0A9CB-AC8B-463C-A889-39FB040672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D6736B-517D-4E36-8C55-17DE4371D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018876-0936-4D16-AFFA-90387C1676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4844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9D440D-5E4D-4560-8E8F-D6807AD7A1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FD976C-9F5E-4AE3-9E92-E3B889FA31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5E27AD-0303-4B23-A915-0B2AE35DA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0225F6-3D6A-452C-B9AA-C8E1BC940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92E47E-045D-41DB-B986-9881D0182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8377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9C4689-4D37-4BF5-B261-F97B6DBDAE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21E1F3-8790-43B3-8D7E-F3F3C18FC4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B8B862-BC2D-4A4F-B7D9-0AF7A7656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721A66-6192-4CE9-9B45-D3301A68D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AA108E-C9AE-403B-8841-2F19EC833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5798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21412E-BBEE-47AA-B143-1D0522C87B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4702E9-1204-4050-99D5-974E51C2B8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67E94C3-F3D9-467C-822C-813DB20B00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383769-3CDC-4C0C-8DC5-45FD70C3C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D15A6E-DB29-4A33-95C2-AB2347B55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DE15E4-7817-42DB-B838-287523189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7607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4A6078-7FA0-4E9C-8A09-A27B176561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5D8DDB-703C-4F07-A39C-FE80CB2512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BBE5F7B-3F93-4C96-B244-69BF1CA5FA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05B8A57-9C37-413C-921F-2DEB5C7E16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F46907-87EC-4FEA-8471-B08AB867AA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50197E-4916-4B42-B527-92159B235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6E2CC0-28C2-4763-8393-5D9504820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2A2B135-20F2-449E-BA20-C237F6847F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337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38D3BA-1D2B-4286-9A12-8229004024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76CC56-C6CB-4464-9F0D-B20F6F0001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6BEA41C-2C12-4B4A-9DCC-99EF63E66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4D73FA-6F1A-4F31-A2E1-C8D345DAB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865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65B487-6EFA-4555-9FBB-D64316F9C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A5C63D-5AD9-455B-BB36-5EA524B322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ABC966F-5A76-49C1-BEE7-7A4C479C9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896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34B81-A41B-4CFC-A661-B46AA9F72D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E025F31-2EE8-406B-B01E-6EFBACF486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1ECA19-1272-46DE-B5A2-FF29A588B6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64AA78-5357-41D2-BCDD-FA9655232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A03966-FCC6-4AD4-A4A7-2EBE5607E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689FAB-9AEF-4C81-84B4-E86A50CBD7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4650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EF212A-8204-4666-AEE7-B1591B53B4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94C02DE-F4F4-42F3-9DC7-E5056878A6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9771FB8-E2A1-4C7F-8F94-83B7653C1B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2ABB0F-97F1-4BC1-AC3D-55939D280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6FB85AB-D7F7-4D07-9E82-A0BD6BB0AD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DA138B1-0033-45D0-A25C-902756386F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5942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A101CC-85C7-4811-8647-F3EAD1288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91718E-C616-4E0E-B70C-323CF8E03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6BC1E4-6373-427E-90B1-9B1B23CA31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BE6C38-225E-45B3-934E-8E6ED36A0A10}" type="datetimeFigureOut">
              <a:rPr lang="en-US" smtClean="0"/>
              <a:t>10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CC3108-C74C-45F1-A77C-67E9FEAB43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83F53C-19B6-4004-8752-4880E872821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DAB701-A0CD-4B3E-82D5-9B1F7A56E20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551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2A604DE-FF7E-4394-9429-FE8BCD8C8C78}"/>
              </a:ext>
            </a:extLst>
          </p:cNvPr>
          <p:cNvSpPr txBox="1"/>
          <p:nvPr/>
        </p:nvSpPr>
        <p:spPr>
          <a:xfrm rot="16200000">
            <a:off x="342762" y="2273104"/>
            <a:ext cx="2196304" cy="3131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otch/GAPDH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RNA Expressio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D35CA0D-F568-48FF-87F4-75E6137ED642}"/>
              </a:ext>
            </a:extLst>
          </p:cNvPr>
          <p:cNvSpPr txBox="1"/>
          <p:nvPr/>
        </p:nvSpPr>
        <p:spPr>
          <a:xfrm>
            <a:off x="1821244" y="1629108"/>
            <a:ext cx="8919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172 cell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9197D29-C28A-46F1-8214-4E858FC769F5}"/>
              </a:ext>
            </a:extLst>
          </p:cNvPr>
          <p:cNvSpPr txBox="1"/>
          <p:nvPr/>
        </p:nvSpPr>
        <p:spPr>
          <a:xfrm rot="16200000">
            <a:off x="1673741" y="2333362"/>
            <a:ext cx="2196304" cy="3131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otch/GAPDH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RNA Expression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2C3902-C439-4FCA-8864-64812C0BE99F}"/>
              </a:ext>
            </a:extLst>
          </p:cNvPr>
          <p:cNvSpPr txBox="1"/>
          <p:nvPr/>
        </p:nvSpPr>
        <p:spPr>
          <a:xfrm>
            <a:off x="3048937" y="1491483"/>
            <a:ext cx="1302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87MG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D3BDD25-CD26-47A3-A12F-00EEF62CB73D}"/>
              </a:ext>
            </a:extLst>
          </p:cNvPr>
          <p:cNvSpPr txBox="1"/>
          <p:nvPr/>
        </p:nvSpPr>
        <p:spPr>
          <a:xfrm>
            <a:off x="5581108" y="1694627"/>
            <a:ext cx="1302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373MG cel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7310828-848D-4EDD-B386-D951215F0369}"/>
              </a:ext>
            </a:extLst>
          </p:cNvPr>
          <p:cNvSpPr txBox="1"/>
          <p:nvPr/>
        </p:nvSpPr>
        <p:spPr>
          <a:xfrm rot="16200000">
            <a:off x="4226687" y="2298421"/>
            <a:ext cx="2196304" cy="313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otch/GAPDH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RNA Expressio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280462E-9F96-4A83-BF3D-74E59591A692}"/>
              </a:ext>
            </a:extLst>
          </p:cNvPr>
          <p:cNvSpPr txBox="1"/>
          <p:nvPr/>
        </p:nvSpPr>
        <p:spPr>
          <a:xfrm rot="16200000">
            <a:off x="2918602" y="2180911"/>
            <a:ext cx="2196304" cy="3131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otch/GAPDH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RNA Expressi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6CB24FA-2FC1-4BDD-A436-470F160715EB}"/>
              </a:ext>
            </a:extLst>
          </p:cNvPr>
          <p:cNvSpPr txBox="1"/>
          <p:nvPr/>
        </p:nvSpPr>
        <p:spPr>
          <a:xfrm>
            <a:off x="4380859" y="1529221"/>
            <a:ext cx="130253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NB19 cells</a:t>
            </a: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96308552-FE94-4EBA-B0AC-E94C7B2C45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8354469"/>
              </p:ext>
            </p:extLst>
          </p:nvPr>
        </p:nvGraphicFramePr>
        <p:xfrm>
          <a:off x="1641023" y="1584090"/>
          <a:ext cx="1063157" cy="1645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Prism Project" r:id="rId3" imgW="3204000" imgH="2412000" progId="Prism5.Document">
                  <p:embed/>
                </p:oleObj>
              </mc:Choice>
              <mc:Fallback>
                <p:oleObj name="Prism Project" r:id="rId3" imgW="3204000" imgH="2412000" progId="Prism5.Document">
                  <p:embed/>
                  <p:pic>
                    <p:nvPicPr>
                      <p:cNvPr id="434" name="Object 433">
                        <a:extLst>
                          <a:ext uri="{FF2B5EF4-FFF2-40B4-BE49-F238E27FC236}">
                            <a16:creationId xmlns:a16="http://schemas.microsoft.com/office/drawing/2014/main" id="{AEE2ADB3-95A6-457F-B035-DB74F768038D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41023" y="1584090"/>
                        <a:ext cx="1063157" cy="1645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81B99651-92A1-4E67-A3F4-2B11D0C3076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3727467"/>
              </p:ext>
            </p:extLst>
          </p:nvPr>
        </p:nvGraphicFramePr>
        <p:xfrm>
          <a:off x="2961326" y="1562523"/>
          <a:ext cx="1063157" cy="1645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Prism Project" r:id="rId5" imgW="3204000" imgH="2448000" progId="Prism5.Document">
                  <p:embed/>
                </p:oleObj>
              </mc:Choice>
              <mc:Fallback>
                <p:oleObj name="Prism Project" r:id="rId5" imgW="3204000" imgH="2448000" progId="Prism5.Document">
                  <p:embed/>
                  <p:pic>
                    <p:nvPicPr>
                      <p:cNvPr id="435" name="Object 434">
                        <a:extLst>
                          <a:ext uri="{FF2B5EF4-FFF2-40B4-BE49-F238E27FC236}">
                            <a16:creationId xmlns:a16="http://schemas.microsoft.com/office/drawing/2014/main" id="{5F3D3970-ED86-48AD-B30F-D2C747D85BEF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61326" y="1562523"/>
                        <a:ext cx="1063157" cy="1645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4" name="Group 13">
            <a:extLst>
              <a:ext uri="{FF2B5EF4-FFF2-40B4-BE49-F238E27FC236}">
                <a16:creationId xmlns:a16="http://schemas.microsoft.com/office/drawing/2014/main" id="{D9AA13BC-18B1-40EF-ADC1-28B5F829208A}"/>
              </a:ext>
            </a:extLst>
          </p:cNvPr>
          <p:cNvGrpSpPr/>
          <p:nvPr/>
        </p:nvGrpSpPr>
        <p:grpSpPr>
          <a:xfrm>
            <a:off x="1723343" y="2248560"/>
            <a:ext cx="865855" cy="1370874"/>
            <a:chOff x="633061" y="1841452"/>
            <a:chExt cx="1191527" cy="1370874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C0694802-0E81-4A0E-A816-B412A39ABD3E}"/>
                </a:ext>
              </a:extLst>
            </p:cNvPr>
            <p:cNvGrpSpPr/>
            <p:nvPr/>
          </p:nvGrpSpPr>
          <p:grpSpPr>
            <a:xfrm>
              <a:off x="633061" y="2371953"/>
              <a:ext cx="1191527" cy="800764"/>
              <a:chOff x="633061" y="2371953"/>
              <a:chExt cx="1191527" cy="800764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DD1365A-D918-4B14-BC1A-3D7E6CCC1EFF}"/>
                  </a:ext>
                </a:extLst>
              </p:cNvPr>
              <p:cNvSpPr txBox="1"/>
              <p:nvPr/>
            </p:nvSpPr>
            <p:spPr>
              <a:xfrm rot="18185430">
                <a:off x="561727" y="2571553"/>
                <a:ext cx="40427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D0CEE187-0D4C-48D4-8C8D-606F56DE73C4}"/>
                  </a:ext>
                </a:extLst>
              </p:cNvPr>
              <p:cNvSpPr txBox="1"/>
              <p:nvPr/>
            </p:nvSpPr>
            <p:spPr>
              <a:xfrm rot="18103320">
                <a:off x="753921" y="2614103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1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4536C48-4371-49B3-8EA9-29AA0E19A98D}"/>
                  </a:ext>
                </a:extLst>
              </p:cNvPr>
              <p:cNvSpPr txBox="1"/>
              <p:nvPr/>
            </p:nvSpPr>
            <p:spPr>
              <a:xfrm rot="18103320">
                <a:off x="906227" y="2668958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 2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7CDA4D5-7883-409E-8766-D7792F46FDAF}"/>
                  </a:ext>
                </a:extLst>
              </p:cNvPr>
              <p:cNvSpPr txBox="1"/>
              <p:nvPr/>
            </p:nvSpPr>
            <p:spPr>
              <a:xfrm rot="18103320">
                <a:off x="1107975" y="2655750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 3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C7831F77-C3E5-4B76-B3C3-DD94273B4B9C}"/>
                  </a:ext>
                </a:extLst>
              </p:cNvPr>
              <p:cNvSpPr txBox="1"/>
              <p:nvPr/>
            </p:nvSpPr>
            <p:spPr>
              <a:xfrm rot="18103320">
                <a:off x="1320828" y="2638700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4</a:t>
                </a:r>
              </a:p>
            </p:txBody>
          </p:sp>
        </p:grp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9E1647A-C956-466E-BE31-7656DE2576EC}"/>
                </a:ext>
              </a:extLst>
            </p:cNvPr>
            <p:cNvSpPr txBox="1"/>
            <p:nvPr/>
          </p:nvSpPr>
          <p:spPr>
            <a:xfrm rot="18185430">
              <a:off x="452579" y="2396084"/>
              <a:ext cx="13708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RPM7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18762E81-600D-4288-9C0C-D355812AB2D8}"/>
              </a:ext>
            </a:extLst>
          </p:cNvPr>
          <p:cNvSpPr txBox="1"/>
          <p:nvPr/>
        </p:nvSpPr>
        <p:spPr>
          <a:xfrm>
            <a:off x="3505648" y="1648683"/>
            <a:ext cx="5622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1AB1283-9E9F-4BBD-89FA-0975363420FF}"/>
              </a:ext>
            </a:extLst>
          </p:cNvPr>
          <p:cNvSpPr txBox="1"/>
          <p:nvPr/>
        </p:nvSpPr>
        <p:spPr>
          <a:xfrm>
            <a:off x="6317441" y="1875996"/>
            <a:ext cx="2797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56F01A7-1F04-4A8A-BE4D-D1AF57478459}"/>
              </a:ext>
            </a:extLst>
          </p:cNvPr>
          <p:cNvSpPr txBox="1"/>
          <p:nvPr/>
        </p:nvSpPr>
        <p:spPr>
          <a:xfrm>
            <a:off x="2465271" y="1866164"/>
            <a:ext cx="2797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BD705526-2373-4C89-96E2-0F895FA8F85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7254953"/>
              </p:ext>
            </p:extLst>
          </p:nvPr>
        </p:nvGraphicFramePr>
        <p:xfrm>
          <a:off x="4193797" y="1517878"/>
          <a:ext cx="1063157" cy="1645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name="Prism Project" r:id="rId7" imgW="3240000" imgH="2448000" progId="Prism5.Document">
                  <p:embed/>
                </p:oleObj>
              </mc:Choice>
              <mc:Fallback>
                <p:oleObj name="Prism Project" r:id="rId7" imgW="3240000" imgH="2448000" progId="Prism5.Document">
                  <p:embed/>
                  <p:pic>
                    <p:nvPicPr>
                      <p:cNvPr id="440" name="Object 439">
                        <a:extLst>
                          <a:ext uri="{FF2B5EF4-FFF2-40B4-BE49-F238E27FC236}">
                            <a16:creationId xmlns:a16="http://schemas.microsoft.com/office/drawing/2014/main" id="{73D3A23E-18AE-4FDD-974C-75DAC9E67BA5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93797" y="1517878"/>
                        <a:ext cx="1063157" cy="1645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TextBox 25">
            <a:extLst>
              <a:ext uri="{FF2B5EF4-FFF2-40B4-BE49-F238E27FC236}">
                <a16:creationId xmlns:a16="http://schemas.microsoft.com/office/drawing/2014/main" id="{274C06B8-DC6E-45AC-A7AB-61449718F18F}"/>
              </a:ext>
            </a:extLst>
          </p:cNvPr>
          <p:cNvSpPr txBox="1"/>
          <p:nvPr/>
        </p:nvSpPr>
        <p:spPr>
          <a:xfrm>
            <a:off x="4761356" y="2325287"/>
            <a:ext cx="4324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aphicFrame>
        <p:nvGraphicFramePr>
          <p:cNvPr id="27" name="Object 26">
            <a:extLst>
              <a:ext uri="{FF2B5EF4-FFF2-40B4-BE49-F238E27FC236}">
                <a16:creationId xmlns:a16="http://schemas.microsoft.com/office/drawing/2014/main" id="{18990ADA-F347-44F8-8EE0-FB75AD5D21F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1851419"/>
              </p:ext>
            </p:extLst>
          </p:nvPr>
        </p:nvGraphicFramePr>
        <p:xfrm>
          <a:off x="5504799" y="1539764"/>
          <a:ext cx="1063157" cy="16459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Prism Project" r:id="rId9" imgW="3096000" imgH="2448000" progId="Prism5.Document">
                  <p:embed/>
                </p:oleObj>
              </mc:Choice>
              <mc:Fallback>
                <p:oleObj name="Prism Project" r:id="rId9" imgW="3096000" imgH="2448000" progId="Prism5.Document">
                  <p:embed/>
                  <p:pic>
                    <p:nvPicPr>
                      <p:cNvPr id="442" name="Object 441">
                        <a:extLst>
                          <a:ext uri="{FF2B5EF4-FFF2-40B4-BE49-F238E27FC236}">
                            <a16:creationId xmlns:a16="http://schemas.microsoft.com/office/drawing/2014/main" id="{B73156B1-C331-4C16-BC66-DDD26C861C1E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504799" y="1539764"/>
                        <a:ext cx="1063157" cy="16459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ABBFB424-F33A-4957-9391-AD138C8FC3FC}"/>
              </a:ext>
            </a:extLst>
          </p:cNvPr>
          <p:cNvSpPr txBox="1"/>
          <p:nvPr/>
        </p:nvSpPr>
        <p:spPr>
          <a:xfrm>
            <a:off x="6206308" y="2206663"/>
            <a:ext cx="2797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pSp>
        <p:nvGrpSpPr>
          <p:cNvPr id="29" name="Group 28">
            <a:extLst>
              <a:ext uri="{FF2B5EF4-FFF2-40B4-BE49-F238E27FC236}">
                <a16:creationId xmlns:a16="http://schemas.microsoft.com/office/drawing/2014/main" id="{B43057DC-61E6-4B72-ABE2-0A07DD03BB62}"/>
              </a:ext>
            </a:extLst>
          </p:cNvPr>
          <p:cNvGrpSpPr/>
          <p:nvPr/>
        </p:nvGrpSpPr>
        <p:grpSpPr>
          <a:xfrm>
            <a:off x="3042181" y="2253526"/>
            <a:ext cx="857476" cy="1370874"/>
            <a:chOff x="736966" y="1841452"/>
            <a:chExt cx="1179997" cy="1370874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59C9463F-10BA-4527-8027-363E80ABE5A5}"/>
                </a:ext>
              </a:extLst>
            </p:cNvPr>
            <p:cNvGrpSpPr/>
            <p:nvPr/>
          </p:nvGrpSpPr>
          <p:grpSpPr>
            <a:xfrm>
              <a:off x="736966" y="2371953"/>
              <a:ext cx="1179997" cy="800764"/>
              <a:chOff x="736966" y="2371953"/>
              <a:chExt cx="1179997" cy="800764"/>
            </a:xfrm>
          </p:grpSpPr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EBFFB099-DC8A-4AAC-8C5C-F29AC2CA8300}"/>
                  </a:ext>
                </a:extLst>
              </p:cNvPr>
              <p:cNvSpPr txBox="1"/>
              <p:nvPr/>
            </p:nvSpPr>
            <p:spPr>
              <a:xfrm rot="18185430">
                <a:off x="665632" y="2571553"/>
                <a:ext cx="40427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7F72596F-DC57-44A0-9380-B2494B499BF9}"/>
                  </a:ext>
                </a:extLst>
              </p:cNvPr>
              <p:cNvSpPr txBox="1"/>
              <p:nvPr/>
            </p:nvSpPr>
            <p:spPr>
              <a:xfrm rot="18103320">
                <a:off x="904000" y="2614103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1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A01FF08C-DC3E-40AB-9671-5E0DBE236D19}"/>
                  </a:ext>
                </a:extLst>
              </p:cNvPr>
              <p:cNvSpPr txBox="1"/>
              <p:nvPr/>
            </p:nvSpPr>
            <p:spPr>
              <a:xfrm rot="18103320">
                <a:off x="1044759" y="2668958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 2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9608AAD5-1ADD-4A87-AB22-175196D218E0}"/>
                  </a:ext>
                </a:extLst>
              </p:cNvPr>
              <p:cNvSpPr txBox="1"/>
              <p:nvPr/>
            </p:nvSpPr>
            <p:spPr>
              <a:xfrm rot="18103320">
                <a:off x="1223424" y="2655750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 3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B25BE91C-CCC0-4F5A-9F09-2A701634279D}"/>
                  </a:ext>
                </a:extLst>
              </p:cNvPr>
              <p:cNvSpPr txBox="1"/>
              <p:nvPr/>
            </p:nvSpPr>
            <p:spPr>
              <a:xfrm rot="18103320">
                <a:off x="1413203" y="2638700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4</a:t>
                </a:r>
              </a:p>
            </p:txBody>
          </p: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4B2F347-E9ED-4648-B552-19C9FFFE7BF4}"/>
                </a:ext>
              </a:extLst>
            </p:cNvPr>
            <p:cNvSpPr txBox="1"/>
            <p:nvPr/>
          </p:nvSpPr>
          <p:spPr>
            <a:xfrm rot="18185430">
              <a:off x="556482" y="2396084"/>
              <a:ext cx="13708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RPM7</a:t>
              </a: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B1A806B9-5A1C-4FFA-8DC5-8CE752E126C7}"/>
              </a:ext>
            </a:extLst>
          </p:cNvPr>
          <p:cNvGrpSpPr/>
          <p:nvPr/>
        </p:nvGrpSpPr>
        <p:grpSpPr>
          <a:xfrm>
            <a:off x="4262646" y="2208804"/>
            <a:ext cx="882645" cy="1370874"/>
            <a:chOff x="736966" y="1841452"/>
            <a:chExt cx="1214632" cy="1370874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90DB2C0E-608A-48D9-A452-78F6DFF9E715}"/>
                </a:ext>
              </a:extLst>
            </p:cNvPr>
            <p:cNvGrpSpPr/>
            <p:nvPr/>
          </p:nvGrpSpPr>
          <p:grpSpPr>
            <a:xfrm>
              <a:off x="736966" y="2371953"/>
              <a:ext cx="1214632" cy="800764"/>
              <a:chOff x="736966" y="2371953"/>
              <a:chExt cx="1214632" cy="800764"/>
            </a:xfrm>
          </p:grpSpPr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028B0A6D-CE74-4834-BDB5-82E9EED2AFBC}"/>
                  </a:ext>
                </a:extLst>
              </p:cNvPr>
              <p:cNvSpPr txBox="1"/>
              <p:nvPr/>
            </p:nvSpPr>
            <p:spPr>
              <a:xfrm rot="18185430">
                <a:off x="665632" y="2571553"/>
                <a:ext cx="40427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B0E13BEA-1E1A-43C4-B135-050F1F861AF7}"/>
                  </a:ext>
                </a:extLst>
              </p:cNvPr>
              <p:cNvSpPr txBox="1"/>
              <p:nvPr/>
            </p:nvSpPr>
            <p:spPr>
              <a:xfrm rot="18103320">
                <a:off x="904000" y="2614103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1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226F9FD6-548C-4446-88AC-CA111FE1F286}"/>
                  </a:ext>
                </a:extLst>
              </p:cNvPr>
              <p:cNvSpPr txBox="1"/>
              <p:nvPr/>
            </p:nvSpPr>
            <p:spPr>
              <a:xfrm rot="18103320">
                <a:off x="1067848" y="2668958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 2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FF1DF051-9107-4488-BF8B-DB991F05663B}"/>
                  </a:ext>
                </a:extLst>
              </p:cNvPr>
              <p:cNvSpPr txBox="1"/>
              <p:nvPr/>
            </p:nvSpPr>
            <p:spPr>
              <a:xfrm rot="18103320">
                <a:off x="1269602" y="2655750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 3</a:t>
                </a: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212DF54B-1D5B-486A-815C-C88534A9217A}"/>
                  </a:ext>
                </a:extLst>
              </p:cNvPr>
              <p:cNvSpPr txBox="1"/>
              <p:nvPr/>
            </p:nvSpPr>
            <p:spPr>
              <a:xfrm rot="18103320">
                <a:off x="1447838" y="2638700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4</a:t>
                </a:r>
              </a:p>
            </p:txBody>
          </p:sp>
        </p:grp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29AD1F39-8FAC-41DC-AFB8-C66751ACD870}"/>
                </a:ext>
              </a:extLst>
            </p:cNvPr>
            <p:cNvSpPr txBox="1"/>
            <p:nvPr/>
          </p:nvSpPr>
          <p:spPr>
            <a:xfrm rot="18185430">
              <a:off x="556482" y="2396084"/>
              <a:ext cx="13708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RPM7</a:t>
              </a:r>
            </a:p>
          </p:txBody>
        </p:sp>
      </p:grpSp>
      <p:grpSp>
        <p:nvGrpSpPr>
          <p:cNvPr id="45" name="Group 44">
            <a:extLst>
              <a:ext uri="{FF2B5EF4-FFF2-40B4-BE49-F238E27FC236}">
                <a16:creationId xmlns:a16="http://schemas.microsoft.com/office/drawing/2014/main" id="{98EF2FF1-D0FB-4362-A44E-ED00B69D0486}"/>
              </a:ext>
            </a:extLst>
          </p:cNvPr>
          <p:cNvGrpSpPr/>
          <p:nvPr/>
        </p:nvGrpSpPr>
        <p:grpSpPr>
          <a:xfrm>
            <a:off x="5532341" y="2234223"/>
            <a:ext cx="916203" cy="1370874"/>
            <a:chOff x="736966" y="1841452"/>
            <a:chExt cx="1260812" cy="1370874"/>
          </a:xfrm>
        </p:grpSpPr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23CFD603-086B-45A6-B9B8-EC67B23EEB9E}"/>
                </a:ext>
              </a:extLst>
            </p:cNvPr>
            <p:cNvGrpSpPr/>
            <p:nvPr/>
          </p:nvGrpSpPr>
          <p:grpSpPr>
            <a:xfrm>
              <a:off x="736966" y="2371953"/>
              <a:ext cx="1260812" cy="800764"/>
              <a:chOff x="736966" y="2371953"/>
              <a:chExt cx="1260812" cy="800764"/>
            </a:xfrm>
          </p:grpSpPr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55338E45-9D78-45DF-8BD2-671C0E9A0AFC}"/>
                  </a:ext>
                </a:extLst>
              </p:cNvPr>
              <p:cNvSpPr txBox="1"/>
              <p:nvPr/>
            </p:nvSpPr>
            <p:spPr>
              <a:xfrm rot="18185430">
                <a:off x="665632" y="2571553"/>
                <a:ext cx="40427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trl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383A7BB3-86BF-4C8A-B705-1853F470C72D}"/>
                  </a:ext>
                </a:extLst>
              </p:cNvPr>
              <p:cNvSpPr txBox="1"/>
              <p:nvPr/>
            </p:nvSpPr>
            <p:spPr>
              <a:xfrm rot="18103320">
                <a:off x="904000" y="2614103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1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E2F3B34E-7301-4156-81F0-F776184C232C}"/>
                  </a:ext>
                </a:extLst>
              </p:cNvPr>
              <p:cNvSpPr txBox="1"/>
              <p:nvPr/>
            </p:nvSpPr>
            <p:spPr>
              <a:xfrm rot="18103320">
                <a:off x="1067848" y="2668958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 2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24A6F411-C95B-429A-BF6F-40ACABAB2287}"/>
                  </a:ext>
                </a:extLst>
              </p:cNvPr>
              <p:cNvSpPr txBox="1"/>
              <p:nvPr/>
            </p:nvSpPr>
            <p:spPr>
              <a:xfrm rot="18103320">
                <a:off x="1304234" y="2655750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 3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92A6EC3C-E545-46B4-A952-F4AC3ED6B82C}"/>
                  </a:ext>
                </a:extLst>
              </p:cNvPr>
              <p:cNvSpPr txBox="1"/>
              <p:nvPr/>
            </p:nvSpPr>
            <p:spPr>
              <a:xfrm rot="18103320">
                <a:off x="1494018" y="2638700"/>
                <a:ext cx="745909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Notch4</a:t>
                </a:r>
              </a:p>
            </p:txBody>
          </p:sp>
        </p:grp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CACA183-8206-4060-ADEE-637259EAF635}"/>
                </a:ext>
              </a:extLst>
            </p:cNvPr>
            <p:cNvSpPr txBox="1"/>
            <p:nvPr/>
          </p:nvSpPr>
          <p:spPr>
            <a:xfrm rot="18185430">
              <a:off x="556482" y="2396084"/>
              <a:ext cx="137087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TRPM7</a:t>
              </a:r>
            </a:p>
          </p:txBody>
        </p:sp>
      </p:grpSp>
      <p:sp>
        <p:nvSpPr>
          <p:cNvPr id="54" name="TextBox 53">
            <a:extLst>
              <a:ext uri="{FF2B5EF4-FFF2-40B4-BE49-F238E27FC236}">
                <a16:creationId xmlns:a16="http://schemas.microsoft.com/office/drawing/2014/main" id="{3E9F2E39-22B2-4D2A-BF77-F08550D67B16}"/>
              </a:ext>
            </a:extLst>
          </p:cNvPr>
          <p:cNvSpPr txBox="1"/>
          <p:nvPr/>
        </p:nvSpPr>
        <p:spPr>
          <a:xfrm>
            <a:off x="4894092" y="2153231"/>
            <a:ext cx="4324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47A3E57-057B-4D80-A2E7-F66F4D6939B1}"/>
              </a:ext>
            </a:extLst>
          </p:cNvPr>
          <p:cNvSpPr txBox="1"/>
          <p:nvPr/>
        </p:nvSpPr>
        <p:spPr>
          <a:xfrm>
            <a:off x="5007164" y="2099159"/>
            <a:ext cx="4324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7543B051-67B5-4F59-8A18-CF9B6DBB5498}"/>
              </a:ext>
            </a:extLst>
          </p:cNvPr>
          <p:cNvSpPr/>
          <p:nvPr/>
        </p:nvSpPr>
        <p:spPr>
          <a:xfrm>
            <a:off x="1238250" y="1377610"/>
            <a:ext cx="31290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en-US" sz="1000" dirty="0"/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D8380A79-09D2-41BA-B084-FDB9BC6AD25B}"/>
              </a:ext>
            </a:extLst>
          </p:cNvPr>
          <p:cNvSpPr/>
          <p:nvPr/>
        </p:nvSpPr>
        <p:spPr>
          <a:xfrm>
            <a:off x="4162425" y="137761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US" sz="1000" dirty="0"/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EA0903AC-6D20-4047-811E-9308DA502C44}"/>
              </a:ext>
            </a:extLst>
          </p:cNvPr>
          <p:cNvSpPr/>
          <p:nvPr/>
        </p:nvSpPr>
        <p:spPr>
          <a:xfrm>
            <a:off x="2924175" y="1377610"/>
            <a:ext cx="312906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en-US" sz="1000" dirty="0"/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FED7CE68-E3F0-4DC1-A559-F8D9297918E5}"/>
              </a:ext>
            </a:extLst>
          </p:cNvPr>
          <p:cNvSpPr/>
          <p:nvPr/>
        </p:nvSpPr>
        <p:spPr>
          <a:xfrm>
            <a:off x="5457825" y="1377610"/>
            <a:ext cx="312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4636058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3</TotalTime>
  <Words>79</Words>
  <Application>Microsoft Office PowerPoint</Application>
  <PresentationFormat>Widescreen</PresentationFormat>
  <Paragraphs>4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Project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Mingli</dc:creator>
  <cp:lastModifiedBy>Liu, Mingli</cp:lastModifiedBy>
  <cp:revision>8</cp:revision>
  <dcterms:created xsi:type="dcterms:W3CDTF">2020-06-13T04:30:53Z</dcterms:created>
  <dcterms:modified xsi:type="dcterms:W3CDTF">2020-10-05T20:34:38Z</dcterms:modified>
</cp:coreProperties>
</file>